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71993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FE580-D142-4B32-B9CD-0D7A0E4460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16160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2FCF6F-5424-4B68-B8D2-64388E27A4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B4BF1-F2AC-42BA-8E18-87A968BA86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47483-6DA8-4E16-B88E-F6C79F720B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B5F88-3C6B-4D67-A711-8813700113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DD6CA-7C45-470C-87AA-9928D44A37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F6739-18FA-4E53-B952-BEE22C1647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A7DACD-CD01-4A2B-99F7-9A2623197B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88720"/>
            <a:ext cx="8229600" cy="556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D754A-F571-476E-94F9-427848B811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505B96-94B2-441A-9428-CD48A91725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684F0-8D96-4ABD-8399-FCD80EA8BF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930B3-3367-4930-B208-08E83A986C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673680"/>
            <a:ext cx="213372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673680"/>
            <a:ext cx="289584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673680"/>
            <a:ext cx="213372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0178E4-9F12-4150-9AB7-145E71194876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785880" y="671400"/>
            <a:ext cx="7643880" cy="5235840"/>
          </a:xfrm>
          <a:prstGeom prst="rect">
            <a:avLst/>
          </a:prstGeom>
          <a:ln w="0">
            <a:noFill/>
          </a:ln>
        </p:spPr>
      </p:pic>
      <p:sp>
        <p:nvSpPr>
          <p:cNvPr id="42" name="TextBox 3"/>
          <p:cNvSpPr/>
          <p:nvPr/>
        </p:nvSpPr>
        <p:spPr>
          <a:xfrm>
            <a:off x="395280" y="6408720"/>
            <a:ext cx="8280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le S4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n example of DNA sequence alignment of Arabidopsis CDS and its homologous Brassica EST and GSS. The nucleotide bases highlighted in grey are the conserved sequences for designing primers for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TIPS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-4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1T06:51:40Z</dcterms:created>
  <dc:creator>NCB203</dc:creator>
  <dc:description/>
  <dc:language>en-US</dc:language>
  <cp:lastModifiedBy>NIPGR</cp:lastModifiedBy>
  <dcterms:modified xsi:type="dcterms:W3CDTF">2012-04-18T11:53:46Z</dcterms:modified>
  <cp:revision>90</cp:revision>
  <dc:subject/>
  <dc:title>Slide 1</dc:title>
</cp:coreProperties>
</file>